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8" autoAdjust="0"/>
    <p:restoredTop sz="94660"/>
  </p:normalViewPr>
  <p:slideViewPr>
    <p:cSldViewPr snapToGrid="0">
      <p:cViewPr varScale="1">
        <p:scale>
          <a:sx n="62" d="100"/>
          <a:sy n="62" d="100"/>
        </p:scale>
        <p:origin x="102" y="9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551286-9568-E5D3-960E-2703E2976E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9E06E15-3475-97D2-5F77-8F307CF001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335A5C-6962-AD95-53B2-0F2D6DCA4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E99699-5B32-E55A-389E-B8EB4AFEF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ED2E8E-77D2-0CBD-F3FB-31C48A4A89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487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CDD717-1B1F-CC88-1673-9A057D4943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E252A9C-028A-4C7F-CD7A-FE98B16CB6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968D88-304D-854C-61F4-07D63D75A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58245D-65F6-2749-1FF3-9B7103F38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1F3B0C-2E8A-6FFB-1403-6C0CC71E7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8455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A238A4E-E2FA-89DB-17CB-929566E84F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CC5B479-D844-1758-BDF0-52A66630C2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99B7B7-7877-5882-F4D2-4BD426EB17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F144AB-955C-56C6-A5D0-1FF5F5DE2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E478C8F-3EED-C6C1-33C5-D3EA36655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224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38D341-626B-13A7-7032-38F3ACCAD6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09534C-E0CD-BF79-295E-201E41356B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53B5C7-68B9-C124-109E-E67D70BE9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CAE7C4-2C57-C3D4-3570-66A9A26BD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CA11E18-CC78-4790-B8AB-EE548E916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74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7D8764-7EF7-DE1A-455D-8FC16A4AB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169E651-8C06-40C3-928B-371548C86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B8ED3FB-5AFC-F50A-5021-7BC4FD753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5963CC1-62FB-5238-5E7E-CF207CD21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EDA03FE-EC14-A804-CA2C-BA0E51A31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690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967B2D-95E5-6AEF-1045-B6758B0D5D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8B561F6-3EF1-0F8C-9B13-F34E264BF2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3A493EE-BB54-8F9A-51C0-579AA2ACF5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31453A7-A8D4-E9F8-7CF6-9F2257375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4A2BCE2-2FAB-8815-F717-CC91160745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D7C294-1481-2AF7-6E46-FC6DEB70A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322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B01DAD-78CA-EA58-34EB-729FD8561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268C3D-8CA3-827E-3CA0-ACCBA47DF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73BEAC2-BC1F-379F-229E-8922669491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1F274C7-BC42-1876-261C-C93113F40C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733A648-8F9E-4010-BBE6-8279D6322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1455EC8-9E47-F346-BA44-B4D51B78E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3402F93-C285-E678-5D2E-D2860E7B2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8760FFF-4280-B206-C8EB-5C083C8632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3687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B37B9A-E83A-BF67-C64F-3C9DE247F3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E66457D-84CA-9A90-70AD-66558F9D9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BA2CE5B-4031-3726-381D-F26F49B69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86A93E4-97DE-E598-66A9-8228C75DB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559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CC27D11-C87B-02FD-015C-0D6074EC8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5EB3D3F-7258-D3B0-28BA-6179C7FD30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F36EB3B-0A78-0D0A-57C0-13400F875C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9518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DCCB4F-7386-A40D-ED94-2D9E26F8D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7B11C9B-112A-341F-B417-E58A9EEED7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3D0D636-D4A0-87D4-F1A4-78EDF800EE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DE83AF6-3AC2-A429-CEEB-E6F48209F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BE4B14A-00A6-C5AC-1CDD-C4207D276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B61EA0-7669-58F8-F368-F406B6CD6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458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3CDAA0-D5F8-77AF-DD44-A2451B95E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3C74A7E-2D56-BD4A-8967-BC0249CE41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7928C9C-4360-D7AF-0EED-8E3F628A3A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3876F9-B143-F556-F212-7AAC0363D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D058C5-5314-0108-8A60-795066863A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DE47760-54C4-57C7-64E6-8626D88D0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0224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54F2EC1-82C2-2966-7702-C034C6FD7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0D0C45-FDA3-A937-FD69-AFEAFA2DE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7D62961-4481-C4FC-43E4-80315441E0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D17603-4505-41F3-8F80-E80CEFE297A6}" type="datetimeFigureOut">
              <a:rPr kumimoji="1" lang="ja-JP" altLang="en-US" smtClean="0"/>
              <a:t>2022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31EC8DD-DB35-2BA0-DD44-A1D492EDD1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3BFD9CE-407E-22D5-0723-96A1E9F17F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56355B-004A-45C2-B6B1-F3E644D0CF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58087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8BB4BA-1673-65C6-DAC7-897696877D4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kumimoji="1" lang="en-US" altLang="ja-JP" dirty="0"/>
              <a:t>Supplemental figures</a:t>
            </a:r>
            <a:endParaRPr kumimoji="1" lang="ja-JP" altLang="en-US" dirty="0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3FE2050-389B-030D-9026-C1A4C17F1D65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074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50A0C3-6620-B380-3B69-BCF522A84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43743"/>
          </a:xfrm>
        </p:spPr>
        <p:txBody>
          <a:bodyPr/>
          <a:lstStyle/>
          <a:p>
            <a:r>
              <a:rPr kumimoji="1" lang="en-US" altLang="ja-JP" dirty="0"/>
              <a:t>Supplemental Fig 1.</a:t>
            </a:r>
            <a:endParaRPr kumimoji="1" lang="ja-JP" altLang="en-US" dirty="0"/>
          </a:p>
        </p:txBody>
      </p:sp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E1B3451D-CD54-A63A-08D0-99FCAB07A29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085724" y="1421024"/>
            <a:ext cx="5174872" cy="5071851"/>
          </a:xfr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2C38145-ABF9-CFE9-1B0D-DF711C01CA8C}"/>
              </a:ext>
            </a:extLst>
          </p:cNvPr>
          <p:cNvSpPr txBox="1"/>
          <p:nvPr/>
        </p:nvSpPr>
        <p:spPr>
          <a:xfrm>
            <a:off x="5542339" y="2891862"/>
            <a:ext cx="25444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The highest Youden index 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FCD1DBA-DFD8-655E-537D-4290909341F1}"/>
              </a:ext>
            </a:extLst>
          </p:cNvPr>
          <p:cNvSpPr txBox="1"/>
          <p:nvPr/>
        </p:nvSpPr>
        <p:spPr>
          <a:xfrm>
            <a:off x="5808630" y="5205468"/>
            <a:ext cx="2278188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 = 0.653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%CI, 0.541-0.766</a:t>
            </a:r>
          </a:p>
        </p:txBody>
      </p:sp>
    </p:spTree>
    <p:extLst>
      <p:ext uri="{BB962C8B-B14F-4D97-AF65-F5344CB8AC3E}">
        <p14:creationId xmlns:p14="http://schemas.microsoft.com/office/powerpoint/2010/main" val="2990204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07F132-7BD3-0898-DED0-214C849078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828244"/>
          </a:xfrm>
        </p:spPr>
        <p:txBody>
          <a:bodyPr/>
          <a:lstStyle/>
          <a:p>
            <a:r>
              <a:rPr kumimoji="1" lang="en-US" altLang="ja-JP" dirty="0"/>
              <a:t>Supplemental Fig 2. RFS</a:t>
            </a:r>
            <a:endParaRPr kumimoji="1" lang="ja-JP" altLang="en-US" dirty="0"/>
          </a:p>
        </p:txBody>
      </p:sp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5DBA8C79-ACEF-168E-5E7C-59D565FCFCF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50929" y="1328183"/>
            <a:ext cx="10515600" cy="5281221"/>
          </a:xfr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3BEF122-F146-D4D6-2437-C42C95C28E21}"/>
              </a:ext>
            </a:extLst>
          </p:cNvPr>
          <p:cNvSpPr txBox="1"/>
          <p:nvPr/>
        </p:nvSpPr>
        <p:spPr>
          <a:xfrm>
            <a:off x="8201659" y="3155464"/>
            <a:ext cx="17171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L)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4029028-A042-1ABD-66C3-18D746012F13}"/>
              </a:ext>
            </a:extLst>
          </p:cNvPr>
          <p:cNvSpPr txBox="1"/>
          <p:nvPr/>
        </p:nvSpPr>
        <p:spPr>
          <a:xfrm>
            <a:off x="8181566" y="3897815"/>
            <a:ext cx="16321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(-) n=28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47B3DBE-CFF6-F283-729E-BBAE16E2B33B}"/>
              </a:ext>
            </a:extLst>
          </p:cNvPr>
          <p:cNvSpPr txBox="1"/>
          <p:nvPr/>
        </p:nvSpPr>
        <p:spPr>
          <a:xfrm>
            <a:off x="8181566" y="4700199"/>
            <a:ext cx="1701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S) n=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2283237-DC87-4989-A584-41CAAB240CC0}"/>
              </a:ext>
            </a:extLst>
          </p:cNvPr>
          <p:cNvSpPr txBox="1"/>
          <p:nvPr/>
        </p:nvSpPr>
        <p:spPr>
          <a:xfrm>
            <a:off x="4197488" y="1516536"/>
            <a:ext cx="52688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L) vs. DR(S)		P&lt;0.001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L) vs. AC(-)		P=0.019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S)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AC(-)		P=0.315</a:t>
            </a:r>
          </a:p>
        </p:txBody>
      </p:sp>
    </p:spTree>
    <p:extLst>
      <p:ext uri="{BB962C8B-B14F-4D97-AF65-F5344CB8AC3E}">
        <p14:creationId xmlns:p14="http://schemas.microsoft.com/office/powerpoint/2010/main" val="11074423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54B231-081D-59FC-6F7A-4DDEFDB34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59241"/>
          </a:xfrm>
        </p:spPr>
        <p:txBody>
          <a:bodyPr/>
          <a:lstStyle/>
          <a:p>
            <a:r>
              <a:rPr kumimoji="1" lang="en-US" altLang="ja-JP" dirty="0"/>
              <a:t>Supplemental Fig 3. OS</a:t>
            </a:r>
            <a:endParaRPr kumimoji="1" lang="ja-JP" altLang="en-US" dirty="0"/>
          </a:p>
        </p:txBody>
      </p:sp>
      <p:pic>
        <p:nvPicPr>
          <p:cNvPr id="5" name="コンテンツ プレースホルダー 4">
            <a:extLst>
              <a:ext uri="{FF2B5EF4-FFF2-40B4-BE49-F238E27FC236}">
                <a16:creationId xmlns:a16="http://schemas.microsoft.com/office/drawing/2014/main" id="{CD230D5D-3313-7902-DA77-1C3BA89944F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38201" y="1441747"/>
            <a:ext cx="9698724" cy="5051128"/>
          </a:xfr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EC17789-8D38-FDC7-1535-A320BC8DE7DA}"/>
              </a:ext>
            </a:extLst>
          </p:cNvPr>
          <p:cNvSpPr txBox="1"/>
          <p:nvPr/>
        </p:nvSpPr>
        <p:spPr>
          <a:xfrm>
            <a:off x="8819787" y="2582025"/>
            <a:ext cx="17171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L)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=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1712658-977F-5791-7100-D05D96FFF0CA}"/>
              </a:ext>
            </a:extLst>
          </p:cNvPr>
          <p:cNvSpPr txBox="1"/>
          <p:nvPr/>
        </p:nvSpPr>
        <p:spPr>
          <a:xfrm>
            <a:off x="8904746" y="3814310"/>
            <a:ext cx="16321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(-) n=28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64AB4FC-8C45-42FD-DAE6-5304BD19687A}"/>
              </a:ext>
            </a:extLst>
          </p:cNvPr>
          <p:cNvSpPr txBox="1"/>
          <p:nvPr/>
        </p:nvSpPr>
        <p:spPr>
          <a:xfrm>
            <a:off x="8835817" y="4691927"/>
            <a:ext cx="1701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S) n=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8BD8502-C2A2-80ED-FE0B-1C81923A4899}"/>
              </a:ext>
            </a:extLst>
          </p:cNvPr>
          <p:cNvSpPr txBox="1"/>
          <p:nvPr/>
        </p:nvSpPr>
        <p:spPr>
          <a:xfrm>
            <a:off x="1934736" y="4122835"/>
            <a:ext cx="526881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L) vs. DR(S)		P&lt;0.001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L) vs. AC(-)		P&lt;0.001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(S)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AC(-)		P=0.750</a:t>
            </a:r>
          </a:p>
        </p:txBody>
      </p:sp>
    </p:spTree>
    <p:extLst>
      <p:ext uri="{BB962C8B-B14F-4D97-AF65-F5344CB8AC3E}">
        <p14:creationId xmlns:p14="http://schemas.microsoft.com/office/powerpoint/2010/main" val="2644801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49</Words>
  <Application>Microsoft Office PowerPoint</Application>
  <PresentationFormat>ワイド画面</PresentationFormat>
  <Paragraphs>1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Office テーマ</vt:lpstr>
      <vt:lpstr>Supplemental figures</vt:lpstr>
      <vt:lpstr>Supplemental Fig 1.</vt:lpstr>
      <vt:lpstr>Supplemental Fig 2. RFS</vt:lpstr>
      <vt:lpstr>Supplemental Fig 3. O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小林 和貴</dc:creator>
  <cp:lastModifiedBy>小林 和貴</cp:lastModifiedBy>
  <cp:revision>4</cp:revision>
  <dcterms:created xsi:type="dcterms:W3CDTF">2022-08-08T16:11:43Z</dcterms:created>
  <dcterms:modified xsi:type="dcterms:W3CDTF">2022-08-09T14:30:38Z</dcterms:modified>
</cp:coreProperties>
</file>